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76C22-DCE1-4E14-8B05-96AC493CB0B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57F338-72DB-45F8-B536-0DA16AD023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538C0-F8F1-432A-AB52-BD85F16CB8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185285-BC37-4C79-B3AC-20D0C7C3E27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589FF0-5997-49AD-9FF2-8B4CA6638CC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DBC7E3-562E-4B42-80F1-E898C0C1B3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18F31E-ED11-419E-A4A9-86082D99EF0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D6CDC9-EDC0-497E-A561-D6A371F1E3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B3DD6-8D07-4624-9F48-4AFB3C21CAE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0BD9C3-0D2E-47D8-B07F-2A09E8FF64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721664-E759-4574-9588-EB2A9C4B54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D8F71-3791-4852-BCBC-9405E655BF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72A66E-E89D-4FCE-A643-5B6D27FB3D8C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990720" y="122400"/>
            <a:ext cx="7543800" cy="6048360"/>
          </a:xfrm>
          <a:prstGeom prst="rect">
            <a:avLst/>
          </a:prstGeom>
          <a:ln w="0">
            <a:noFill/>
          </a:ln>
        </p:spPr>
      </p:pic>
      <p:sp>
        <p:nvSpPr>
          <p:cNvPr id="42" name="TextBox 17"/>
          <p:cNvSpPr/>
          <p:nvPr/>
        </p:nvSpPr>
        <p:spPr>
          <a:xfrm>
            <a:off x="744480" y="6149880"/>
            <a:ext cx="792468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upplementary figure 2│ A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lignment of Jas domain showing conserved ‘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KR(K/N/R/Q)(E/D/I/V)R 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’ motif among 32 </a:t>
            </a:r>
            <a:r>
              <a:rPr b="1" i="1" lang="en-US" sz="1400" spc="-1" strike="noStrike">
                <a:solidFill>
                  <a:srgbClr val="000000"/>
                </a:solidFill>
                <a:latin typeface="Calibri"/>
              </a:rPr>
              <a:t>B. rapa</a:t>
            </a: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 TIFY proteins.</a:t>
            </a: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 Protein name and respective E-value has been marked on the left side of the alignmen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5-23T14:44:42Z</dcterms:created>
  <dc:creator>Gopal Saha</dc:creator>
  <dc:description/>
  <dc:language>en-US</dc:language>
  <cp:lastModifiedBy>Gopal Saha</cp:lastModifiedBy>
  <dcterms:modified xsi:type="dcterms:W3CDTF">2016-05-23T14:45:23Z</dcterms:modified>
  <cp:revision>1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2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2.PPT</vt:lpwstr>
  </property>
</Properties>
</file>